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13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488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4621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3478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509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110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768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040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466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2679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7267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493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9A0A2-AD18-4FDD-8961-82CA269F27CF}" type="datetimeFigureOut">
              <a:rPr lang="zh-CN" altLang="en-US" smtClean="0"/>
              <a:t>2023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CF13A-E400-4C9C-AE86-BD7FAF9314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0306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C130B74-53F0-51FE-B399-68AA373FF818}"/>
              </a:ext>
            </a:extLst>
          </p:cNvPr>
          <p:cNvSpPr txBox="1"/>
          <p:nvPr/>
        </p:nvSpPr>
        <p:spPr>
          <a:xfrm>
            <a:off x="55500" y="4943082"/>
            <a:ext cx="12081000" cy="4639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: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unnel plot (A) and sensitivity analysis (B) of the association between vitamin D deficiency and TG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2100" y="872990"/>
            <a:ext cx="4880416" cy="32549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138" y="590906"/>
            <a:ext cx="4979952" cy="36225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72534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C130B74-53F0-51FE-B399-68AA373FF818}"/>
              </a:ext>
            </a:extLst>
          </p:cNvPr>
          <p:cNvSpPr txBox="1"/>
          <p:nvPr/>
        </p:nvSpPr>
        <p:spPr>
          <a:xfrm>
            <a:off x="55500" y="4943082"/>
            <a:ext cx="12081000" cy="4639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: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unnel plot (A) and sensitivity analysis (B) of the association between vitamin D deficiency and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C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7903" y="932130"/>
            <a:ext cx="5117239" cy="341291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868" y="494141"/>
            <a:ext cx="5715035" cy="4149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521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C130B74-53F0-51FE-B399-68AA373FF818}"/>
              </a:ext>
            </a:extLst>
          </p:cNvPr>
          <p:cNvSpPr txBox="1"/>
          <p:nvPr/>
        </p:nvSpPr>
        <p:spPr>
          <a:xfrm>
            <a:off x="55500" y="4943082"/>
            <a:ext cx="12081000" cy="4639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: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unnel plot (A) and sensitivity analysis (B) of the association between vitamin D deficiency and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DL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677" y="910057"/>
            <a:ext cx="4846684" cy="351937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1101" y="705103"/>
            <a:ext cx="6215835" cy="4145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3235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C130B74-53F0-51FE-B399-68AA373FF818}"/>
              </a:ext>
            </a:extLst>
          </p:cNvPr>
          <p:cNvSpPr txBox="1"/>
          <p:nvPr/>
        </p:nvSpPr>
        <p:spPr>
          <a:xfrm>
            <a:off x="55500" y="4943082"/>
            <a:ext cx="12081000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: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unnel plot (A) and sensitivity analysis (B) of the association between vitamin D deficiency and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DL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2113" y="731943"/>
            <a:ext cx="5373887" cy="390913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2324" y="1223586"/>
            <a:ext cx="4760189" cy="3174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1508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96</Words>
  <Application>Microsoft Office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黄 潇</dc:creator>
  <cp:lastModifiedBy>艳 杨</cp:lastModifiedBy>
  <cp:revision>2</cp:revision>
  <dcterms:created xsi:type="dcterms:W3CDTF">2023-03-16T19:53:21Z</dcterms:created>
  <dcterms:modified xsi:type="dcterms:W3CDTF">2023-03-20T10:27:58Z</dcterms:modified>
</cp:coreProperties>
</file>